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498"/>
    <p:restoredTop sz="94674"/>
  </p:normalViewPr>
  <p:slideViewPr>
    <p:cSldViewPr snapToGrid="0" snapToObjects="1">
      <p:cViewPr varScale="1">
        <p:scale>
          <a:sx n="129" d="100"/>
          <a:sy n="129" d="100"/>
        </p:scale>
        <p:origin x="232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CA7D5F7-F757-9A4A-8602-984B2C1052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11FD7BA3-AC44-0942-9A74-1831571FBD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9C0F4F5-D30A-F74B-ACA9-CB48B13AD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960E2070-4FB0-A041-8BC6-245AAE5DF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EFC6020-32F1-B24A-A849-C9826CB003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090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01B2267-DE69-2F44-9699-6F5D01D104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56D9EEA-E5A0-C041-A125-26FE75CD16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2C06E15-5C51-3246-B1EC-45A1DDD0D8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1E49F54-16E1-BF45-9F83-DB2CB0290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BAED509-F455-3544-A38B-CF6F1A870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8183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93939D43-DA72-EB45-8C1D-812BFF8635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30B88DB-74C6-F643-A44E-A53C8E0245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1A88970-37A4-3048-92DE-A0CB7C1AB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700B7B3-A584-E842-B155-CEC2E94E9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A8E741F-C994-6B42-8756-648062CC03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03091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74E9622-5005-8647-B18E-9D761D914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AEB8F15-B102-C04A-A901-39E3B0641D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AA25C91-6BE2-EA4D-95CE-CB33B085AE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5663064-81B8-3E4E-A864-5AF0143515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4C52730-4BAC-C247-AC91-8197210C8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3396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34E7BB4-1796-F94C-BFC1-C7EC809D5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32958758-9312-8D41-B37F-15284E226C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35364EE-7D08-7841-87E9-3652E6C00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009B6B9-F5EF-7F43-866D-A5A75DA488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6BCC977-084E-9242-BF93-34CD3FED92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9596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6271476-0324-A649-A743-C23158855C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BEAFEB5-0009-3945-8433-0665DBF93E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88B7006-D9C2-474C-98A6-BC9462641E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0097D59-DFB0-8740-97E6-13F0D228D9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2B79BE76-F3D5-EE45-93F0-B861E0731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DC7B73C-09D0-5D40-899E-A72372B1C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6100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FD9F56F-8CEA-6943-AB0C-D75B139BA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F480A64-9122-DF47-85F9-2C40F270E0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7058530-0213-F944-9881-3923EAC275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A0F4F94-D3CA-CF4B-A23B-CEE8576999C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7751FD36-4D0F-5144-ACC4-BA9D7D45661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0060F70-D4B4-1C43-B568-7F4A4579E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E9AE304D-1F18-7F49-88A9-1DE91F790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2B8E1A22-5A43-7B4D-ABD0-A31756169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2162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B80E414-F82E-1046-BB29-DCA44D199D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4FFB0DF-CAA0-B243-B34B-BCC145E4EB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66769B5D-DD7D-2440-936A-C09EE3C467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3D1DBA43-2A9F-BD48-A2C0-C2F32F4AF2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10888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CB3913A-A18E-F74E-ACD3-B95E9282D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08E989F-1C7D-1544-B3BC-A804DA525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A5EB0F83-144A-A84F-97BF-8A48F4D92F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6218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60C7FD2-77D0-9547-AD9F-988344BD57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A19AF09C-8A76-1645-8CF5-5F26AB388B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D57931E-3CAD-1544-B4BB-A3DE0E1CED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C3B0B3-196E-5641-81F0-7F22D60DD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603E076-BF22-4245-8580-29FA21286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4865570-31D8-1048-86F7-F8A560E67B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561519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BDCE769-A0EB-6344-9752-CA31445B0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C7CD3E7-C092-F74D-98C2-B866E427D5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76DA264E-1DC1-7045-9AF0-E16839639D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4096A86-EB23-7F41-9C60-D898880F8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5B573DE7-992B-F542-9995-D00D870857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08D850B-98BE-C843-961C-9E5F60460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3889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568C19C-777A-794C-A73A-81B4DA516D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5D3E592-7631-D946-93D2-B7FDE0CA13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B18CF87-8E57-F24E-A059-707FC1B481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2BB94F-6ECA-5F45-864B-489591472E56}" type="datetimeFigureOut">
              <a:rPr lang="fr-FR" smtClean="0"/>
              <a:t>20/0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39E83D8-1568-6346-9C6E-22A564119F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4CD7A67-7F04-8942-A614-65FC0BEBD5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4582C5-E93B-7547-BFAF-4745B9A240D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6475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F91D5CF-2C7E-FC45-A37A-07F8DD32F2E4}"/>
              </a:ext>
            </a:extLst>
          </p:cNvPr>
          <p:cNvSpPr/>
          <p:nvPr/>
        </p:nvSpPr>
        <p:spPr>
          <a:xfrm>
            <a:off x="2055778" y="4534446"/>
            <a:ext cx="930008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000" b="1" dirty="0">
                <a:latin typeface="Times" pitchFamily="2" charset="0"/>
                <a:ea typeface="Times New Roman" panose="02020603050405020304" pitchFamily="18" charset="0"/>
              </a:rPr>
              <a:t>S2 Fig. Effect of IPTG on Huh7 cells proliferation following constitutive sh129921-mediated </a:t>
            </a:r>
            <a:r>
              <a:rPr lang="en-GB" sz="1000" b="1" i="1" dirty="0">
                <a:latin typeface="Times" pitchFamily="2" charset="0"/>
                <a:ea typeface="Times New Roman" panose="02020603050405020304" pitchFamily="18" charset="0"/>
              </a:rPr>
              <a:t>MPV17</a:t>
            </a:r>
            <a:r>
              <a:rPr lang="en-GB" sz="1000" b="1" dirty="0">
                <a:latin typeface="Times" pitchFamily="2" charset="0"/>
                <a:ea typeface="Times New Roman" panose="02020603050405020304" pitchFamily="18" charset="0"/>
              </a:rPr>
              <a:t> knockdown. </a:t>
            </a:r>
            <a:r>
              <a:rPr lang="en-GB" sz="1000" dirty="0">
                <a:latin typeface="Times" pitchFamily="2" charset="0"/>
              </a:rPr>
              <a:t>Huh7 cells were transduced with non-target shRNA lentiviral vectors (</a:t>
            </a:r>
            <a:r>
              <a:rPr lang="en-GB" sz="1000" dirty="0" err="1">
                <a:latin typeface="Times" pitchFamily="2" charset="0"/>
              </a:rPr>
              <a:t>shNT</a:t>
            </a:r>
            <a:r>
              <a:rPr lang="en-GB" sz="1000" dirty="0">
                <a:latin typeface="Times" pitchFamily="2" charset="0"/>
              </a:rPr>
              <a:t>) or with sh129921-containing vector. Transduced cells were selected for 6 days with puromycin (2.5 </a:t>
            </a:r>
            <a:r>
              <a:rPr lang="en-GB" sz="1000" dirty="0">
                <a:latin typeface="Times" pitchFamily="2" charset="0"/>
                <a:sym typeface="Symbol" pitchFamily="2" charset="2"/>
              </a:rPr>
              <a:t></a:t>
            </a:r>
            <a:r>
              <a:rPr lang="en-GB" sz="1000" dirty="0">
                <a:latin typeface="Times" pitchFamily="2" charset="0"/>
              </a:rPr>
              <a:t>g/mL). Cells were seeded at 8×10</a:t>
            </a:r>
            <a:r>
              <a:rPr lang="en-GB" sz="1000" baseline="30000" dirty="0">
                <a:latin typeface="Times" pitchFamily="2" charset="0"/>
              </a:rPr>
              <a:t>3</a:t>
            </a:r>
            <a:r>
              <a:rPr lang="en-GB" sz="1000" dirty="0">
                <a:latin typeface="Times" pitchFamily="2" charset="0"/>
              </a:rPr>
              <a:t> cells/cm</a:t>
            </a:r>
            <a:r>
              <a:rPr lang="en-GB" sz="1000" baseline="30000" dirty="0">
                <a:latin typeface="Times" pitchFamily="2" charset="0"/>
              </a:rPr>
              <a:t>2</a:t>
            </a:r>
            <a:r>
              <a:rPr lang="en-GB" sz="1000" dirty="0">
                <a:latin typeface="Times" pitchFamily="2" charset="0"/>
              </a:rPr>
              <a:t> and grown for 4 days in the presence or in the absence of 0.1 </a:t>
            </a:r>
            <a:r>
              <a:rPr lang="en-GB" sz="1000" dirty="0" err="1">
                <a:latin typeface="Times" pitchFamily="2" charset="0"/>
              </a:rPr>
              <a:t>mM</a:t>
            </a:r>
            <a:r>
              <a:rPr lang="en-GB" sz="1000" dirty="0">
                <a:latin typeface="Times" pitchFamily="2" charset="0"/>
              </a:rPr>
              <a:t> of IPTG. To mimic the conditions found in the inducible model of expression, the IPTG-containing medium was renewed daily. We therefore included a control in which no IPTG was present while the medium was also changed every day (</a:t>
            </a:r>
            <a:r>
              <a:rPr lang="en-GB" sz="1000" dirty="0" err="1">
                <a:latin typeface="Times" pitchFamily="2" charset="0"/>
              </a:rPr>
              <a:t>Ctl</a:t>
            </a:r>
            <a:r>
              <a:rPr lang="en-GB" sz="1000" dirty="0">
                <a:latin typeface="Times" pitchFamily="2" charset="0"/>
              </a:rPr>
              <a:t>). Data are presented as mean ± S.E.M (3 biological replicates). P values were calculated with the one-tailed Mann-Whitney Test (</a:t>
            </a:r>
            <a:r>
              <a:rPr lang="en-US" sz="1000" dirty="0">
                <a:latin typeface="Times" pitchFamily="2" charset="0"/>
              </a:rPr>
              <a:t>⍺</a:t>
            </a:r>
            <a:r>
              <a:rPr lang="en-GB" sz="1000" dirty="0">
                <a:latin typeface="Times" pitchFamily="2" charset="0"/>
              </a:rPr>
              <a:t> = 5 %; NS; *: p&lt;0.05; **: p&lt;0.01; ***: p&lt;0.001).</a:t>
            </a:r>
            <a:endParaRPr lang="fr-BE" sz="1000" dirty="0">
              <a:latin typeface="Times" pitchFamily="2" charset="0"/>
            </a:endParaRPr>
          </a:p>
          <a:p>
            <a:pPr algn="just">
              <a:spcAft>
                <a:spcPts val="0"/>
              </a:spcAft>
            </a:pPr>
            <a:endParaRPr lang="fr-BE" sz="1000" dirty="0">
              <a:effectLst/>
              <a:latin typeface="Times" pitchFamily="2" charset="0"/>
              <a:ea typeface="Times New Roman" panose="02020603050405020304" pitchFamily="18" charset="0"/>
            </a:endParaRPr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A1F88ADD-E781-9248-A723-3E772CB1E8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3871" y="1202633"/>
            <a:ext cx="3258407" cy="33031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3690501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63</Words>
  <Application>Microsoft Macintosh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Symbol</vt:lpstr>
      <vt:lpstr>Times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14</cp:revision>
  <cp:lastPrinted>2019-06-25T11:58:27Z</cp:lastPrinted>
  <dcterms:created xsi:type="dcterms:W3CDTF">2019-03-06T14:55:43Z</dcterms:created>
  <dcterms:modified xsi:type="dcterms:W3CDTF">2020-02-20T13:29:50Z</dcterms:modified>
</cp:coreProperties>
</file>